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15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68ADA-88E0-48A7-995E-BC4C80EA19D3}" type="datetimeFigureOut">
              <a:rPr lang="en-GB" smtClean="0"/>
              <a:t>18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8AE09-9489-482B-8D00-67294C937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3199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68ADA-88E0-48A7-995E-BC4C80EA19D3}" type="datetimeFigureOut">
              <a:rPr lang="en-GB" smtClean="0"/>
              <a:t>18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8AE09-9489-482B-8D00-67294C937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01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68ADA-88E0-48A7-995E-BC4C80EA19D3}" type="datetimeFigureOut">
              <a:rPr lang="en-GB" smtClean="0"/>
              <a:t>18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8AE09-9489-482B-8D00-67294C937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4559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68ADA-88E0-48A7-995E-BC4C80EA19D3}" type="datetimeFigureOut">
              <a:rPr lang="en-GB" smtClean="0"/>
              <a:t>18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8AE09-9489-482B-8D00-67294C937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640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68ADA-88E0-48A7-995E-BC4C80EA19D3}" type="datetimeFigureOut">
              <a:rPr lang="en-GB" smtClean="0"/>
              <a:t>18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8AE09-9489-482B-8D00-67294C937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1647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68ADA-88E0-48A7-995E-BC4C80EA19D3}" type="datetimeFigureOut">
              <a:rPr lang="en-GB" smtClean="0"/>
              <a:t>18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8AE09-9489-482B-8D00-67294C937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8481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68ADA-88E0-48A7-995E-BC4C80EA19D3}" type="datetimeFigureOut">
              <a:rPr lang="en-GB" smtClean="0"/>
              <a:t>18/05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8AE09-9489-482B-8D00-67294C937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8805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68ADA-88E0-48A7-995E-BC4C80EA19D3}" type="datetimeFigureOut">
              <a:rPr lang="en-GB" smtClean="0"/>
              <a:t>18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8AE09-9489-482B-8D00-67294C937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1836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68ADA-88E0-48A7-995E-BC4C80EA19D3}" type="datetimeFigureOut">
              <a:rPr lang="en-GB" smtClean="0"/>
              <a:t>18/05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8AE09-9489-482B-8D00-67294C937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275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68ADA-88E0-48A7-995E-BC4C80EA19D3}" type="datetimeFigureOut">
              <a:rPr lang="en-GB" smtClean="0"/>
              <a:t>18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8AE09-9489-482B-8D00-67294C937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7472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68ADA-88E0-48A7-995E-BC4C80EA19D3}" type="datetimeFigureOut">
              <a:rPr lang="en-GB" smtClean="0"/>
              <a:t>18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8AE09-9489-482B-8D00-67294C937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8588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268ADA-88E0-48A7-995E-BC4C80EA19D3}" type="datetimeFigureOut">
              <a:rPr lang="en-GB" smtClean="0"/>
              <a:t>18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38AE09-9489-482B-8D00-67294C937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8518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4181" y="6482380"/>
            <a:ext cx="56609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Supplementary Figure 1</a:t>
            </a:r>
          </a:p>
        </p:txBody>
      </p:sp>
      <p:sp>
        <p:nvSpPr>
          <p:cNvPr id="6" name="Rectangle 5"/>
          <p:cNvSpPr/>
          <p:nvPr/>
        </p:nvSpPr>
        <p:spPr>
          <a:xfrm>
            <a:off x="436181" y="833528"/>
            <a:ext cx="7985967" cy="10595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rgbClr val="000000"/>
                </a:solidFill>
                <a:latin typeface="Arial"/>
                <a:cs typeface="Arial"/>
              </a:rPr>
              <a:t>1297 citations identified by initial search of MEDLINE and EMBASE databases (1946-2018]) </a:t>
            </a:r>
            <a:r>
              <a:rPr lang="en-CA" dirty="0">
                <a:solidFill>
                  <a:srgbClr val="000000"/>
                </a:solidFill>
                <a:latin typeface="Arial"/>
                <a:cs typeface="Arial"/>
              </a:rPr>
              <a:t>in which the text word </a:t>
            </a:r>
            <a:r>
              <a:rPr lang="en-US" dirty="0">
                <a:solidFill>
                  <a:srgbClr val="000000"/>
                </a:solidFill>
                <a:latin typeface="Arial"/>
                <a:cs typeface="Arial"/>
              </a:rPr>
              <a:t>“frail*” and “card*” or “</a:t>
            </a:r>
            <a:r>
              <a:rPr lang="en-US" dirty="0" err="1">
                <a:solidFill>
                  <a:srgbClr val="000000"/>
                </a:solidFill>
                <a:latin typeface="Arial"/>
                <a:cs typeface="Arial"/>
              </a:rPr>
              <a:t>coronar</a:t>
            </a:r>
            <a:r>
              <a:rPr lang="en-US" dirty="0">
                <a:solidFill>
                  <a:srgbClr val="000000"/>
                </a:solidFill>
                <a:latin typeface="Arial"/>
                <a:cs typeface="Arial"/>
              </a:rPr>
              <a:t>*” and “</a:t>
            </a:r>
            <a:r>
              <a:rPr lang="en-US" dirty="0" err="1">
                <a:solidFill>
                  <a:srgbClr val="000000"/>
                </a:solidFill>
                <a:latin typeface="Arial"/>
                <a:cs typeface="Arial"/>
              </a:rPr>
              <a:t>surg</a:t>
            </a:r>
            <a:r>
              <a:rPr lang="en-US" dirty="0">
                <a:solidFill>
                  <a:srgbClr val="000000"/>
                </a:solidFill>
                <a:latin typeface="Arial"/>
                <a:cs typeface="Arial"/>
              </a:rPr>
              <a:t>*” </a:t>
            </a:r>
            <a:r>
              <a:rPr lang="en-CA" dirty="0">
                <a:solidFill>
                  <a:srgbClr val="000000"/>
                </a:solidFill>
                <a:latin typeface="Arial"/>
                <a:cs typeface="Arial"/>
              </a:rPr>
              <a:t>were mentioned in the title or abstract</a:t>
            </a:r>
            <a:endParaRPr lang="en-US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4713832" y="2164877"/>
            <a:ext cx="4103912" cy="641822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rgbClr val="000000"/>
                </a:solidFill>
                <a:latin typeface="Arial"/>
              </a:rPr>
              <a:t>1219 ineligible on basis of 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Arial"/>
              </a:rPr>
              <a:t>title and abstract screening</a:t>
            </a:r>
          </a:p>
        </p:txBody>
      </p:sp>
      <p:sp>
        <p:nvSpPr>
          <p:cNvPr id="8" name="Rectangle 7"/>
          <p:cNvSpPr/>
          <p:nvPr/>
        </p:nvSpPr>
        <p:spPr>
          <a:xfrm>
            <a:off x="1390608" y="3088349"/>
            <a:ext cx="5747475" cy="577212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rgbClr val="000000"/>
                </a:solidFill>
                <a:latin typeface="Arial"/>
              </a:rPr>
              <a:t>78 retrieved for full text review</a:t>
            </a:r>
          </a:p>
        </p:txBody>
      </p:sp>
      <p:sp>
        <p:nvSpPr>
          <p:cNvPr id="9" name="Rectangle 8"/>
          <p:cNvSpPr/>
          <p:nvPr/>
        </p:nvSpPr>
        <p:spPr>
          <a:xfrm>
            <a:off x="1441902" y="5337624"/>
            <a:ext cx="5706420" cy="55316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rgbClr val="000000"/>
                </a:solidFill>
                <a:latin typeface="Arial"/>
                <a:cs typeface="Arial"/>
              </a:rPr>
              <a:t>19 observational studies were included</a:t>
            </a: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4264761" y="1893046"/>
            <a:ext cx="2627" cy="1195303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4310697" y="3665561"/>
            <a:ext cx="0" cy="1672063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4295112" y="2500618"/>
            <a:ext cx="436187" cy="0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4683482" y="3864461"/>
            <a:ext cx="4325052" cy="136793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solidFill>
                  <a:srgbClr val="000000"/>
                </a:solidFill>
                <a:latin typeface="Arial"/>
              </a:rPr>
              <a:t>59 Excluded based on:</a:t>
            </a:r>
          </a:p>
          <a:p>
            <a:r>
              <a:rPr lang="en-US" sz="1600" dirty="0">
                <a:solidFill>
                  <a:srgbClr val="000000"/>
                </a:solidFill>
                <a:latin typeface="Arial"/>
              </a:rPr>
              <a:t>31 - Conference abstract only</a:t>
            </a:r>
          </a:p>
          <a:p>
            <a:r>
              <a:rPr lang="en-US" sz="1600" dirty="0">
                <a:solidFill>
                  <a:srgbClr val="000000"/>
                </a:solidFill>
                <a:latin typeface="Arial"/>
              </a:rPr>
              <a:t>20 - Study design</a:t>
            </a:r>
          </a:p>
          <a:p>
            <a:r>
              <a:rPr lang="en-US" sz="1600" dirty="0">
                <a:solidFill>
                  <a:srgbClr val="000000"/>
                </a:solidFill>
                <a:latin typeface="Arial"/>
              </a:rPr>
              <a:t>3   - Outcomes not reported</a:t>
            </a:r>
          </a:p>
          <a:p>
            <a:r>
              <a:rPr lang="en-US" sz="1600" dirty="0">
                <a:solidFill>
                  <a:srgbClr val="000000"/>
                </a:solidFill>
                <a:latin typeface="Arial"/>
              </a:rPr>
              <a:t>5   - Procedures not primarily </a:t>
            </a:r>
          </a:p>
          <a:p>
            <a:r>
              <a:rPr lang="en-US" sz="1600" dirty="0">
                <a:solidFill>
                  <a:srgbClr val="000000"/>
                </a:solidFill>
                <a:latin typeface="Arial"/>
              </a:rPr>
              <a:t>         CABG or valve surgery</a:t>
            </a: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4264761" y="4415295"/>
            <a:ext cx="436187" cy="0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408248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4180" y="6468712"/>
            <a:ext cx="77351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Supplementary Figure 2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3C4D36A4-9D88-41B6-A0C3-EE257D5DDC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97000"/>
            <a:ext cx="9144000" cy="406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72805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4181" y="6477705"/>
            <a:ext cx="8408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Supplementary Figure 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C880B348-4A0E-4B3D-AE2C-E75E185AF4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50" y="1828800"/>
            <a:ext cx="9080500" cy="320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18886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4181" y="6477705"/>
            <a:ext cx="8408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Supplementary Figure 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5E498984-43C9-4FDD-9F85-F68BFC2B95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550" y="2171700"/>
            <a:ext cx="8978900" cy="2514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77075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20F068A0-65BD-4E2B-B43D-34B3182E40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47383"/>
            <a:ext cx="9144000" cy="376323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44181" y="6489547"/>
            <a:ext cx="8408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21850616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4181" y="6489547"/>
            <a:ext cx="8408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Supplementary Figure 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EB4C3994-2214-4F1C-AC7A-3B83D844F2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66570"/>
            <a:ext cx="9144000" cy="41248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7225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8</Words>
  <Application>Microsoft Office PowerPoint</Application>
  <PresentationFormat>On-screen Show (4:3)</PresentationFormat>
  <Paragraphs>17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FRENACIA</dc:creator>
  <cp:lastModifiedBy>AFRENACIA</cp:lastModifiedBy>
  <cp:revision>1</cp:revision>
  <dcterms:created xsi:type="dcterms:W3CDTF">2021-05-18T01:01:57Z</dcterms:created>
  <dcterms:modified xsi:type="dcterms:W3CDTF">2021-05-18T01:02:51Z</dcterms:modified>
</cp:coreProperties>
</file>